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9991B6-EFF4-42D2-B813-966134F20EB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35668B-58BF-4E57-ACF7-2163E2D6A6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BAA94A-45DF-4965-B3C7-0F578272277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A7B4D6-0BC2-471C-9341-E6B55F84FEB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8C617E-C361-4FDD-83A0-CD1F6C74F5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C6101C-30AC-4E94-B818-7528887C03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B4593F-66A2-4D08-B5A5-894A9CAE26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837D91-6E0F-4CE4-AA53-E9BD8979A2C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68DCE4-E69B-4CC4-B1E8-7FB0811F4A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179FFB-A8B4-4595-89D2-A0896B43B2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1389F1-4B16-4BF4-9D58-712524A38B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9E73DC-0E06-4851-B350-8129762CF0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62D938C-D331-42B1-BF0C-7345C9DC12AB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グラフ 6" descr=""/>
          <p:cNvPicPr/>
          <p:nvPr/>
        </p:nvPicPr>
        <p:blipFill>
          <a:blip r:embed="rId1"/>
          <a:stretch/>
        </p:blipFill>
        <p:spPr>
          <a:xfrm>
            <a:off x="73080" y="3224160"/>
            <a:ext cx="4492440" cy="2706840"/>
          </a:xfrm>
          <a:prstGeom prst="rect">
            <a:avLst/>
          </a:prstGeom>
          <a:ln w="0">
            <a:noFill/>
          </a:ln>
        </p:spPr>
      </p:pic>
      <p:pic>
        <p:nvPicPr>
          <p:cNvPr id="42" name="グラフ 7" descr=""/>
          <p:cNvPicPr/>
          <p:nvPr/>
        </p:nvPicPr>
        <p:blipFill>
          <a:blip r:embed="rId2"/>
          <a:stretch/>
        </p:blipFill>
        <p:spPr>
          <a:xfrm>
            <a:off x="4591080" y="3224160"/>
            <a:ext cx="4486320" cy="2706840"/>
          </a:xfrm>
          <a:prstGeom prst="rect">
            <a:avLst/>
          </a:prstGeom>
          <a:ln w="0">
            <a:noFill/>
          </a:ln>
        </p:spPr>
      </p:pic>
      <p:pic>
        <p:nvPicPr>
          <p:cNvPr id="43" name="グラフ 8" descr=""/>
          <p:cNvPicPr/>
          <p:nvPr/>
        </p:nvPicPr>
        <p:blipFill>
          <a:blip r:embed="rId3"/>
          <a:stretch/>
        </p:blipFill>
        <p:spPr>
          <a:xfrm>
            <a:off x="2335320" y="450720"/>
            <a:ext cx="4492440" cy="2700360"/>
          </a:xfrm>
          <a:prstGeom prst="rect">
            <a:avLst/>
          </a:prstGeom>
          <a:ln w="0">
            <a:noFill/>
          </a:ln>
        </p:spPr>
      </p:pic>
      <p:sp>
        <p:nvSpPr>
          <p:cNvPr id="44" name="直線コネクタ 10"/>
          <p:cNvSpPr/>
          <p:nvPr/>
        </p:nvSpPr>
        <p:spPr>
          <a:xfrm flipH="1">
            <a:off x="1275840" y="1676520"/>
            <a:ext cx="1081080" cy="1584360"/>
          </a:xfrm>
          <a:prstGeom prst="line">
            <a:avLst/>
          </a:prstGeom>
          <a:ln w="2844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テキスト ボックス 11"/>
          <p:cNvSpPr/>
          <p:nvPr/>
        </p:nvSpPr>
        <p:spPr>
          <a:xfrm>
            <a:off x="441360" y="1655640"/>
            <a:ext cx="17002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ja-JP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= 0.9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milar </a:t>
            </a: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distributi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テキスト ボックス 14"/>
          <p:cNvSpPr/>
          <p:nvPr/>
        </p:nvSpPr>
        <p:spPr>
          <a:xfrm>
            <a:off x="6973920" y="1655640"/>
            <a:ext cx="2093760" cy="106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P = 5.8×10</a:t>
            </a:r>
            <a:r>
              <a:rPr b="1" lang="en-US" sz="1600" spc="-1" strike="noStrike" baseline="30000">
                <a:solidFill>
                  <a:srgbClr val="000000"/>
                </a:solidFill>
                <a:latin typeface="Arial"/>
              </a:rPr>
              <a:t>-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gnificantly different distributi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テキスト ボックス 13"/>
          <p:cNvSpPr/>
          <p:nvPr/>
        </p:nvSpPr>
        <p:spPr>
          <a:xfrm>
            <a:off x="307800" y="139680"/>
            <a:ext cx="8479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. Frequencies of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LA-DQB1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lleles after removal of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QB1*06:02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effect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テキスト ボックス 14"/>
          <p:cNvSpPr/>
          <p:nvPr/>
        </p:nvSpPr>
        <p:spPr>
          <a:xfrm>
            <a:off x="511200" y="5952960"/>
            <a:ext cx="80708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overall frequency distribution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LA-DQB1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lleles in NA-CA group was compared with that in another group using the global Chi-square test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A-CA: narcolepsy with cataplexy, NA w/o CA: narcolepsy without cataplex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直線コネクタ 10"/>
          <p:cNvSpPr/>
          <p:nvPr/>
        </p:nvSpPr>
        <p:spPr>
          <a:xfrm>
            <a:off x="6794640" y="1676520"/>
            <a:ext cx="1081080" cy="1584360"/>
          </a:xfrm>
          <a:prstGeom prst="line">
            <a:avLst/>
          </a:prstGeom>
          <a:ln w="2844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6-24T07:54:52Z</dcterms:created>
  <dc:creator>Windows ユーザー</dc:creator>
  <dc:description/>
  <dc:language>en-US</dc:language>
  <cp:lastModifiedBy>R.Vijitha</cp:lastModifiedBy>
  <dcterms:modified xsi:type="dcterms:W3CDTF">2015-09-07T04:43:33Z</dcterms:modified>
  <cp:revision>8</cp:revision>
  <dc:subject/>
  <dc:title>PowerPoint プレゼンテーション</dc:title>
</cp:coreProperties>
</file>